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arp, Robert E." initials="SRE" lastIdx="0" clrIdx="0">
    <p:extLst>
      <p:ext uri="{19B8F6BF-5375-455C-9EA6-DF929625EA0E}">
        <p15:presenceInfo xmlns:p15="http://schemas.microsoft.com/office/powerpoint/2012/main" userId="S-1-5-21-201074022-649947792-1237804090-293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66" d="100"/>
          <a:sy n="66" d="100"/>
        </p:scale>
        <p:origin x="2154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DA7A6A-EF0A-40DF-B5EE-F2AC734D209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048F4C-FBEF-4BAC-A530-E7B4B1500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1571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048F4C-FBEF-4BAC-A530-E7B4B15007B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9825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239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652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930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83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294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005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954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15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809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215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669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19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/>
          <p:cNvSpPr/>
          <p:nvPr/>
        </p:nvSpPr>
        <p:spPr>
          <a:xfrm>
            <a:off x="749257" y="3880500"/>
            <a:ext cx="5791200" cy="1711639"/>
          </a:xfrm>
          <a:prstGeom prst="rect">
            <a:avLst/>
          </a:prstGeom>
        </p:spPr>
        <p:txBody>
          <a:bodyPr wrap="square" lIns="82058" tIns="41029" rIns="82058" bIns="41029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Figure S1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xalate oxidase activity measured by oxidation of 4-chloro-1-naphthol, seen as dark blue staining, in approximately 12-mm apical segments of the primary root of CK44 oxalate oxidase transgenic (Trans) and wild-type lines at 72 h after transplanting to well-watered (WW) or water-stressed (WS; -1.6 MPa) conditions. The experiments were repeated with similar results and representative images are shown.</a:t>
            </a:r>
          </a:p>
          <a:p>
            <a:pPr>
              <a:lnSpc>
                <a:spcPct val="150000"/>
              </a:lnSpc>
            </a:pP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17835" y="1971283"/>
            <a:ext cx="5934947" cy="1723448"/>
            <a:chOff x="317835" y="3038083"/>
            <a:chExt cx="5934947" cy="1723448"/>
          </a:xfrm>
        </p:grpSpPr>
        <p:sp>
          <p:nvSpPr>
            <p:cNvPr id="13" name="TextBox 12"/>
            <p:cNvSpPr txBox="1"/>
            <p:nvPr/>
          </p:nvSpPr>
          <p:spPr>
            <a:xfrm>
              <a:off x="5091605" y="3451901"/>
              <a:ext cx="10228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Trans WS</a:t>
              </a:r>
            </a:p>
          </p:txBody>
        </p:sp>
        <p:pic>
          <p:nvPicPr>
            <p:cNvPr id="4" name="Picture 4" descr="C:\Documents and Settings\pv7vc\Desktop\MCC_Jan20_2010_Onwards\CK44_Null_Trans_CellLength_WW_72hrs\WW_NullT8_72hrs_1x.tif"/>
            <p:cNvPicPr preferRelativeResize="0"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 rot="10800000">
              <a:off x="1174695" y="3736968"/>
              <a:ext cx="1198036" cy="1024320"/>
            </a:xfrm>
            <a:prstGeom prst="rect">
              <a:avLst/>
            </a:prstGeom>
            <a:noFill/>
          </p:spPr>
        </p:pic>
        <p:pic>
          <p:nvPicPr>
            <p:cNvPr id="5" name="Picture 2" descr="C:\Documents and Settings\pv7vc\Desktop\MCC_Jan20_2010_Onwards\CK44_T8_OXOsatining_Jan2011\CK44_T8_Null_WS_72_1x.tif"/>
            <p:cNvPicPr preferRelativeResize="0">
              <a:picLocks noChangeAspect="1" noChangeArrowheads="1"/>
            </p:cNvPicPr>
            <p:nvPr/>
          </p:nvPicPr>
          <p:blipFill rotWithShape="1">
            <a:blip r:embed="rId4" cstate="print"/>
            <a:srcRect l="2" r="884"/>
            <a:stretch/>
          </p:blipFill>
          <p:spPr bwMode="auto">
            <a:xfrm>
              <a:off x="2457426" y="3736076"/>
              <a:ext cx="1187431" cy="1024320"/>
            </a:xfrm>
            <a:prstGeom prst="rect">
              <a:avLst/>
            </a:prstGeom>
            <a:noFill/>
          </p:spPr>
        </p:pic>
        <p:pic>
          <p:nvPicPr>
            <p:cNvPr id="6" name="Picture 3" descr="C:\Documents and Settings\pv7vc\Desktop\MCC_Jan20_2010_Onwards\CK44_T8_OXOsatining_Jan2011\CK44_T8_Trans_WS_72_1x.tif"/>
            <p:cNvPicPr>
              <a:picLocks noChangeAspect="1" noChangeArrowheads="1"/>
            </p:cNvPicPr>
            <p:nvPr/>
          </p:nvPicPr>
          <p:blipFill rotWithShape="1">
            <a:blip r:embed="rId5" cstate="print"/>
            <a:srcRect l="1" r="-3164"/>
            <a:stretch/>
          </p:blipFill>
          <p:spPr bwMode="auto">
            <a:xfrm>
              <a:off x="5016556" y="3736968"/>
              <a:ext cx="1236226" cy="1024563"/>
            </a:xfrm>
            <a:prstGeom prst="rect">
              <a:avLst/>
            </a:prstGeom>
            <a:noFill/>
          </p:spPr>
        </p:pic>
        <p:pic>
          <p:nvPicPr>
            <p:cNvPr id="7" name="Picture 5" descr="C:\Documents and Settings\pv7vc\Desktop\MCC_Jan20_2010_Onwards\CK44_Null_Trans_CellLength_WW_72hrs\WW_TransT8_72hrs_1x.tif"/>
            <p:cNvPicPr preferRelativeResize="0"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 rot="10800000">
              <a:off x="3737712" y="3736968"/>
              <a:ext cx="1198036" cy="1024320"/>
            </a:xfrm>
            <a:prstGeom prst="rect">
              <a:avLst/>
            </a:prstGeom>
            <a:noFill/>
          </p:spPr>
        </p:pic>
        <p:sp>
          <p:nvSpPr>
            <p:cNvPr id="11" name="TextBox 10"/>
            <p:cNvSpPr txBox="1"/>
            <p:nvPr/>
          </p:nvSpPr>
          <p:spPr>
            <a:xfrm>
              <a:off x="1143000" y="3451901"/>
              <a:ext cx="12508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>
                  <a:latin typeface="Times New Roman" pitchFamily="18" charset="0"/>
                  <a:cs typeface="Times New Roman" pitchFamily="18" charset="0"/>
                </a:rPr>
                <a:t>Wildtype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 WW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795420" y="3451901"/>
              <a:ext cx="10826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Trans WW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30439" y="3448733"/>
              <a:ext cx="12264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>
                  <a:latin typeface="Times New Roman" pitchFamily="18" charset="0"/>
                  <a:cs typeface="Times New Roman" pitchFamily="18" charset="0"/>
                </a:rPr>
                <a:t>Wildtype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 WS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143000" y="3707373"/>
              <a:ext cx="788878" cy="289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2 mm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1329458" y="3946582"/>
              <a:ext cx="1693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447657" y="3548330"/>
              <a:ext cx="668028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K44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17835" y="3038083"/>
              <a:ext cx="27942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orting Information Figure S1</a:t>
              </a: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24518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89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othuluru, Priyamvada (MU-Student)</dc:creator>
  <cp:lastModifiedBy>Voothuluru</cp:lastModifiedBy>
  <cp:revision>19</cp:revision>
  <dcterms:created xsi:type="dcterms:W3CDTF">2014-01-13T20:26:51Z</dcterms:created>
  <dcterms:modified xsi:type="dcterms:W3CDTF">2020-03-30T22:24:02Z</dcterms:modified>
</cp:coreProperties>
</file>